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FB934-9B8B-49EA-A530-2CCDD3B432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C5BAD-5BBA-4902-83D8-FB93C57E4F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55B3F-9302-44D0-9457-210177DA9D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20F4B5-080E-4DAA-AB3A-F037046279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34C29-0B9A-4044-995E-24919E3195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67D7E-61CB-476D-81FC-8C27C50A2A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D9B72-7363-4D08-BD48-25EC0B1511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6A4BA-6A59-4D9E-B8A1-5A481AA445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3AD5F-E983-4603-A831-406ACDDF77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A2959-E927-4630-97BB-26798FF3F7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E74BA-12F0-4CF6-86A2-8BFCBEA35A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19EE3-C071-46DD-9FC1-B42B70F7D7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6EAFEE-1B28-4AE4-ACC2-1474CC1D7D7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3044880" y="5392800"/>
            <a:ext cx="6121440" cy="10778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l Figure 1.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A scatter plot and regression graph depicting daily systolic blood pressure measurements following a 12-week intervention period in CON (a) (n=7), EXR (b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7), BRJ (c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8), EXR &amp; BRJ (d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7) groups. Linear regression lines, correlation coefficient (r), and P-value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)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are displayed in the above graphs. P-value and correlation coefficient were calculated via one-tailed Pearson’s correlation coefficient. Significance is defined as P&lt;0.05. Abbreviations: EXR, Exercise; BRJ, Beetroot Juice; CON, Control; SBP, Systolic Blood Pressure.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Object 15"/>
          <p:cNvGraphicFramePr/>
          <p:nvPr/>
        </p:nvGraphicFramePr>
        <p:xfrm>
          <a:off x="2421000" y="585720"/>
          <a:ext cx="3686040" cy="2462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1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21000" y="585720"/>
                    <a:ext cx="3686040" cy="246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Object 16"/>
          <p:cNvGraphicFramePr/>
          <p:nvPr/>
        </p:nvGraphicFramePr>
        <p:xfrm>
          <a:off x="6229440" y="585720"/>
          <a:ext cx="3700440" cy="2454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Object 1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29440" y="585720"/>
                    <a:ext cx="3700440" cy="245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Object 17"/>
          <p:cNvGraphicFramePr/>
          <p:nvPr/>
        </p:nvGraphicFramePr>
        <p:xfrm>
          <a:off x="6232680" y="2886120"/>
          <a:ext cx="3686040" cy="2454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7" name="Object 1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232680" y="2886120"/>
                    <a:ext cx="3686040" cy="245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Object 18"/>
          <p:cNvGraphicFramePr/>
          <p:nvPr/>
        </p:nvGraphicFramePr>
        <p:xfrm>
          <a:off x="2416320" y="2889360"/>
          <a:ext cx="3686040" cy="2454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9" name="Object 1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416320" y="2889360"/>
                    <a:ext cx="3686040" cy="245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18"/>
          <p:cNvSpPr/>
          <p:nvPr/>
        </p:nvSpPr>
        <p:spPr>
          <a:xfrm>
            <a:off x="152280" y="152280"/>
            <a:ext cx="12192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02T18:46:42Z</dcterms:created>
  <dc:creator>Osman, Mubarak</dc:creator>
  <dc:description/>
  <dc:language>en-US</dc:language>
  <cp:lastModifiedBy>td</cp:lastModifiedBy>
  <dcterms:modified xsi:type="dcterms:W3CDTF">2023-08-26T05:40:01Z</dcterms:modified>
  <cp:revision>1</cp:revision>
  <dc:subject/>
  <dc:title>PowerPoint Presentation</dc:title>
</cp:coreProperties>
</file>